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1302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468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5450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539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6701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3348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23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653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559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7491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2984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5143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02B9E-E92D-42A9-8CCF-90B1EB28A840}" type="datetimeFigureOut">
              <a:rPr lang="en-GB" smtClean="0"/>
              <a:t>30/10/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433FC-00F0-4C14-82AB-7389FEE149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1052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4657641"/>
              </p:ext>
            </p:extLst>
          </p:nvPr>
        </p:nvGraphicFramePr>
        <p:xfrm>
          <a:off x="149800" y="1628800"/>
          <a:ext cx="8892478" cy="2664297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  <a:gridCol w="635177"/>
              </a:tblGrid>
              <a:tr h="296033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Total </a:t>
                      </a:r>
                      <a:r>
                        <a:rPr lang="en-GB" sz="1200" b="1" u="none" strike="noStrike" dirty="0" smtClean="0">
                          <a:effectLst/>
                        </a:rPr>
                        <a:t>adherent cells (counts/</a:t>
                      </a:r>
                      <a:r>
                        <a:rPr lang="en-GB" sz="1200" b="1" u="none" strike="noStrike" dirty="0" err="1" smtClean="0">
                          <a:effectLst/>
                        </a:rPr>
                        <a:t>ul</a:t>
                      </a:r>
                      <a:r>
                        <a:rPr lang="en-GB" sz="1200" b="1" u="none" strike="noStrike" dirty="0" smtClean="0">
                          <a:effectLst/>
                        </a:rPr>
                        <a:t>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 smtClean="0">
                          <a:effectLst/>
                        </a:rPr>
                        <a:t>CD34+</a:t>
                      </a:r>
                      <a:r>
                        <a:rPr lang="en-GB" sz="1200" b="1" u="none" strike="noStrike" baseline="0" dirty="0" smtClean="0">
                          <a:effectLst/>
                        </a:rPr>
                        <a:t> cells (counts/</a:t>
                      </a:r>
                      <a:r>
                        <a:rPr lang="en-GB" sz="1200" b="1" u="none" strike="noStrike" baseline="0" dirty="0" err="1" smtClean="0">
                          <a:effectLst/>
                        </a:rPr>
                        <a:t>ul</a:t>
                      </a:r>
                      <a:r>
                        <a:rPr lang="en-GB" sz="1200" b="1" u="none" strike="noStrike" baseline="0" dirty="0" smtClean="0">
                          <a:effectLst/>
                        </a:rPr>
                        <a:t>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</a:rPr>
                        <a:t>Apoptotic cells/total cells (%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960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control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0-4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4-7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0-7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Control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0-4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4-7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0-7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control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0-4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4-7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</a:rPr>
                        <a:t>D0-7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96033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74.9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73.72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77.1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17.73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6.06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28.89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7.4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79.42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6.4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.4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9.6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1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96033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0.9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07.29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41.49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75.96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7.6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76.74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5.2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0.9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8.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.4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9.6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2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96033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86.70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36.0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24.69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72.0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22.98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40.41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42.05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02.21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.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.9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.3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.5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96033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19.66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68.8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52.38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523.61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09.36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24.53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28.66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25.72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4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.3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0.7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96033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1.76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93.51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95.3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46.15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7.4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0.0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4.09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66.3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.3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7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.5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.0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96033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7.33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77.51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8.4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92.59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0.70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3.2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9.5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5.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7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.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.5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  <a:tr h="296033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99.00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84.0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92.00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43.9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1.2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09.77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1.8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81.20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0.6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0.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0.9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0.53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5937095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</Words>
  <Application>Microsoft Office PowerPoint</Application>
  <PresentationFormat>Bildschirmpräsentation (4:3)</PresentationFormat>
  <Paragraphs>9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therine</dc:creator>
  <cp:lastModifiedBy>Catherine</cp:lastModifiedBy>
  <cp:revision>2</cp:revision>
  <dcterms:created xsi:type="dcterms:W3CDTF">2016-10-30T09:52:48Z</dcterms:created>
  <dcterms:modified xsi:type="dcterms:W3CDTF">2016-10-30T10:27:24Z</dcterms:modified>
</cp:coreProperties>
</file>